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  <p:sldId id="266" r:id="rId3"/>
    <p:sldId id="267" r:id="rId4"/>
    <p:sldId id="273" r:id="rId5"/>
    <p:sldId id="274" r:id="rId6"/>
    <p:sldId id="264" r:id="rId7"/>
    <p:sldId id="270" r:id="rId8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CA2BE"/>
    <a:srgbClr val="89CC40"/>
    <a:srgbClr val="BF2375"/>
    <a:srgbClr val="E86B44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211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-145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62618-CFA6-4851-8C70-B7CB7111A72D}" type="datetimeFigureOut">
              <a:rPr lang="en-ZA" smtClean="0"/>
              <a:pPr/>
              <a:t>21/02/201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17608-94D7-46AE-9E0B-5947BFC1B295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62618-CFA6-4851-8C70-B7CB7111A72D}" type="datetimeFigureOut">
              <a:rPr lang="en-ZA" smtClean="0"/>
              <a:pPr/>
              <a:t>21/02/201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17608-94D7-46AE-9E0B-5947BFC1B295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62618-CFA6-4851-8C70-B7CB7111A72D}" type="datetimeFigureOut">
              <a:rPr lang="en-ZA" smtClean="0"/>
              <a:pPr/>
              <a:t>21/02/201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17608-94D7-46AE-9E0B-5947BFC1B295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62618-CFA6-4851-8C70-B7CB7111A72D}" type="datetimeFigureOut">
              <a:rPr lang="en-ZA" smtClean="0"/>
              <a:pPr/>
              <a:t>21/02/201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17608-94D7-46AE-9E0B-5947BFC1B295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62618-CFA6-4851-8C70-B7CB7111A72D}" type="datetimeFigureOut">
              <a:rPr lang="en-ZA" smtClean="0"/>
              <a:pPr/>
              <a:t>21/02/201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17608-94D7-46AE-9E0B-5947BFC1B295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62618-CFA6-4851-8C70-B7CB7111A72D}" type="datetimeFigureOut">
              <a:rPr lang="en-ZA" smtClean="0"/>
              <a:pPr/>
              <a:t>21/02/201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17608-94D7-46AE-9E0B-5947BFC1B295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62618-CFA6-4851-8C70-B7CB7111A72D}" type="datetimeFigureOut">
              <a:rPr lang="en-ZA" smtClean="0"/>
              <a:pPr/>
              <a:t>21/02/2014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17608-94D7-46AE-9E0B-5947BFC1B295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62618-CFA6-4851-8C70-B7CB7111A72D}" type="datetimeFigureOut">
              <a:rPr lang="en-ZA" smtClean="0"/>
              <a:pPr/>
              <a:t>21/02/2014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17608-94D7-46AE-9E0B-5947BFC1B295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62618-CFA6-4851-8C70-B7CB7111A72D}" type="datetimeFigureOut">
              <a:rPr lang="en-ZA" smtClean="0"/>
              <a:pPr/>
              <a:t>21/02/2014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17608-94D7-46AE-9E0B-5947BFC1B295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62618-CFA6-4851-8C70-B7CB7111A72D}" type="datetimeFigureOut">
              <a:rPr lang="en-ZA" smtClean="0"/>
              <a:pPr/>
              <a:t>21/02/201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17608-94D7-46AE-9E0B-5947BFC1B295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62618-CFA6-4851-8C70-B7CB7111A72D}" type="datetimeFigureOut">
              <a:rPr lang="en-ZA" smtClean="0"/>
              <a:pPr/>
              <a:t>21/02/201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17608-94D7-46AE-9E0B-5947BFC1B295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862618-CFA6-4851-8C70-B7CB7111A72D}" type="datetimeFigureOut">
              <a:rPr lang="en-ZA" smtClean="0"/>
              <a:pPr/>
              <a:t>21/02/201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17608-94D7-46AE-9E0B-5947BFC1B295}" type="slidenum">
              <a:rPr lang="en-ZA" smtClean="0"/>
              <a:pPr/>
              <a:t>‹#›</a:t>
            </a:fld>
            <a:endParaRPr lang="en-Z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 cstate="print">
            <a:lum/>
          </a:blip>
          <a:srcRect/>
          <a:stretch>
            <a:fillRect l="5000" t="5000" r="15000" b="20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/>
          <p:cNvSpPr txBox="1"/>
          <p:nvPr/>
        </p:nvSpPr>
        <p:spPr>
          <a:xfrm>
            <a:off x="7391690" y="324342"/>
            <a:ext cx="563565" cy="5141393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>
              <a:lnSpc>
                <a:spcPct val="79000"/>
              </a:lnSpc>
            </a:pP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Rv2450c rpfE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2476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24670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2477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BCG_2470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2526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UL_3732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MAR_3776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P2273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V_1722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3569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3637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Kmcs_3564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2619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3962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4643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B_1597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2620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3961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3568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3636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3563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4640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Rv1884c </a:t>
            </a: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rpfC1884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1895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1916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BCG_1921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1932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19060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P1607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V_2818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L2030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UL_2975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MAR_2772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Rv2389c</a:t>
            </a:r>
            <a:r>
              <a:rPr lang="en-ZA" sz="500" dirty="0" smtClean="0">
                <a:latin typeface="Arial" pitchFamily="34" charset="0"/>
                <a:cs typeface="Arial" pitchFamily="34" charset="0"/>
              </a:rPr>
              <a:t> rpfD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2413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2458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2410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BCG_2403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24030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OCU_26380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B_4080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Rv1009</a:t>
            </a:r>
            <a:r>
              <a:rPr lang="en-ZA" sz="500" dirty="0" smtClean="0">
                <a:latin typeface="Arial" pitchFamily="34" charset="0"/>
                <a:cs typeface="Arial" pitchFamily="34" charset="0"/>
              </a:rPr>
              <a:t> rpfB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1018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1038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10190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1036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BCG_1066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V_1147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P0974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OCU_10320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UL_4651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MAR_4479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L0240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4643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4350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4264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5439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1932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4801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1689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1758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1712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B_1130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08760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0890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0874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Rv0867c</a:t>
            </a:r>
            <a:r>
              <a:rPr lang="en-ZA" sz="500" dirty="0" smtClean="0">
                <a:latin typeface="Arial" pitchFamily="34" charset="0"/>
                <a:cs typeface="Arial" pitchFamily="34" charset="0"/>
              </a:rPr>
              <a:t> rpfA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BCG_0919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0891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MAR_4665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UL_0283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V_0996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P_0805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OCU_08710</a:t>
            </a: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L2151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4566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4479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4862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5049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1703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5700</a:t>
            </a:r>
          </a:p>
          <a:p>
            <a:pPr>
              <a:lnSpc>
                <a:spcPct val="79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B_0869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OCU_18020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822193" y="5957038"/>
            <a:ext cx="74193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 smtClean="0"/>
              <a:t>Supplementary Figure S1. </a:t>
            </a:r>
            <a:r>
              <a:rPr lang="en-ZA" sz="1200" dirty="0" smtClean="0"/>
              <a:t>Phylogenetic relationship between Resuscitation Promoting Factors from various mycobacteria</a:t>
            </a:r>
            <a:endParaRPr lang="en-ZA" sz="1200" dirty="0"/>
          </a:p>
        </p:txBody>
      </p:sp>
      <p:sp>
        <p:nvSpPr>
          <p:cNvPr id="8" name="Right Brace 7"/>
          <p:cNvSpPr/>
          <p:nvPr/>
        </p:nvSpPr>
        <p:spPr>
          <a:xfrm>
            <a:off x="7959017" y="1733551"/>
            <a:ext cx="379120" cy="661987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9" name="Right Brace 8"/>
          <p:cNvSpPr/>
          <p:nvPr/>
        </p:nvSpPr>
        <p:spPr>
          <a:xfrm>
            <a:off x="7959017" y="395289"/>
            <a:ext cx="379120" cy="1285874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10" name="Right Brace 9"/>
          <p:cNvSpPr/>
          <p:nvPr/>
        </p:nvSpPr>
        <p:spPr>
          <a:xfrm>
            <a:off x="7959017" y="2447927"/>
            <a:ext cx="379120" cy="447112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1" name="Right Brace 10"/>
          <p:cNvSpPr/>
          <p:nvPr/>
        </p:nvSpPr>
        <p:spPr>
          <a:xfrm>
            <a:off x="7959017" y="2928938"/>
            <a:ext cx="379120" cy="1304925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2" name="Right Brace 11"/>
          <p:cNvSpPr/>
          <p:nvPr/>
        </p:nvSpPr>
        <p:spPr>
          <a:xfrm>
            <a:off x="7959017" y="4291014"/>
            <a:ext cx="379120" cy="1133474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3" name="TextBox 2"/>
          <p:cNvSpPr txBox="1"/>
          <p:nvPr/>
        </p:nvSpPr>
        <p:spPr>
          <a:xfrm>
            <a:off x="8307141" y="830313"/>
            <a:ext cx="567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err="1" smtClean="0"/>
              <a:t>rpfE</a:t>
            </a:r>
            <a:endParaRPr lang="en-ZA" i="1" dirty="0"/>
          </a:p>
        </p:txBody>
      </p:sp>
      <p:sp>
        <p:nvSpPr>
          <p:cNvPr id="14" name="TextBox 13"/>
          <p:cNvSpPr txBox="1"/>
          <p:nvPr/>
        </p:nvSpPr>
        <p:spPr>
          <a:xfrm>
            <a:off x="8370581" y="3475316"/>
            <a:ext cx="577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err="1" smtClean="0"/>
              <a:t>rpfB</a:t>
            </a:r>
            <a:endParaRPr lang="en-ZA" i="1" dirty="0"/>
          </a:p>
        </p:txBody>
      </p:sp>
      <p:sp>
        <p:nvSpPr>
          <p:cNvPr id="15" name="TextBox 14"/>
          <p:cNvSpPr txBox="1"/>
          <p:nvPr/>
        </p:nvSpPr>
        <p:spPr>
          <a:xfrm>
            <a:off x="8343138" y="2486817"/>
            <a:ext cx="594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err="1" smtClean="0"/>
              <a:t>rpfD</a:t>
            </a:r>
            <a:endParaRPr lang="en-ZA" i="1" dirty="0"/>
          </a:p>
        </p:txBody>
      </p:sp>
      <p:sp>
        <p:nvSpPr>
          <p:cNvPr id="16" name="TextBox 15"/>
          <p:cNvSpPr txBox="1"/>
          <p:nvPr/>
        </p:nvSpPr>
        <p:spPr>
          <a:xfrm>
            <a:off x="8338137" y="1827490"/>
            <a:ext cx="572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err="1" smtClean="0"/>
              <a:t>rpfC</a:t>
            </a:r>
            <a:endParaRPr lang="en-ZA" i="1" dirty="0"/>
          </a:p>
        </p:txBody>
      </p:sp>
      <p:sp>
        <p:nvSpPr>
          <p:cNvPr id="17" name="TextBox 16"/>
          <p:cNvSpPr txBox="1"/>
          <p:nvPr/>
        </p:nvSpPr>
        <p:spPr>
          <a:xfrm>
            <a:off x="8338137" y="4727852"/>
            <a:ext cx="585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err="1" smtClean="0"/>
              <a:t>rpfA</a:t>
            </a:r>
            <a:endParaRPr lang="en-ZA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 cstate="print">
            <a:lum/>
          </a:blip>
          <a:srcRect/>
          <a:stretch>
            <a:fillRect l="5000" t="5000" r="15000" b="20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/>
          <p:cNvSpPr txBox="1"/>
          <p:nvPr/>
        </p:nvSpPr>
        <p:spPr>
          <a:xfrm>
            <a:off x="7219351" y="248943"/>
            <a:ext cx="662045" cy="529760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>
              <a:lnSpc>
                <a:spcPct val="152000"/>
              </a:lnSpc>
            </a:pP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3707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BCG_3741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36900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3784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3717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Rv3682 ponA2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UL_4257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MAR_5171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V_0446</a:t>
            </a: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P0392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OCU_03970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L2308</a:t>
            </a: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4825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4911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5212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6201</a:t>
            </a: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1365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5442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B_0408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1505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1483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1480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1068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5209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4384 ponA3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0056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00500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0053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BCG_0081</a:t>
            </a: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0051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Rv0050 ponA1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UL_0068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MAR_0069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V_0071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P0064</a:t>
            </a: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OCU_00670</a:t>
            </a: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L2688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5748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5461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5372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0871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3036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2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6900</a:t>
            </a:r>
          </a:p>
          <a:p>
            <a:pPr>
              <a:lnSpc>
                <a:spcPct val="152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B_4901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814444" y="5949289"/>
            <a:ext cx="74193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 smtClean="0"/>
              <a:t>Supplementary Figure S2</a:t>
            </a:r>
            <a:r>
              <a:rPr lang="en-ZA" sz="1200" dirty="0"/>
              <a:t>. Phylogenetic relationship between </a:t>
            </a:r>
            <a:r>
              <a:rPr lang="en-ZA" sz="1200" dirty="0" smtClean="0"/>
              <a:t>Class A penicillin binding </a:t>
            </a:r>
            <a:r>
              <a:rPr lang="en-ZA" sz="1200" dirty="0" smtClean="0"/>
              <a:t>proteins (</a:t>
            </a:r>
            <a:r>
              <a:rPr lang="en-ZA" sz="1200" dirty="0" err="1" smtClean="0"/>
              <a:t>PonA</a:t>
            </a:r>
            <a:r>
              <a:rPr lang="en-ZA" sz="1200" dirty="0" smtClean="0"/>
              <a:t> family) </a:t>
            </a:r>
            <a:r>
              <a:rPr lang="en-ZA" sz="1200" dirty="0" smtClean="0"/>
              <a:t>from </a:t>
            </a:r>
            <a:r>
              <a:rPr lang="en-ZA" sz="1200" dirty="0"/>
              <a:t>various </a:t>
            </a:r>
            <a:r>
              <a:rPr lang="en-ZA" sz="1200" dirty="0" smtClean="0"/>
              <a:t>mycobacteria</a:t>
            </a:r>
            <a:endParaRPr lang="en-ZA" sz="1200" dirty="0"/>
          </a:p>
        </p:txBody>
      </p:sp>
      <p:sp>
        <p:nvSpPr>
          <p:cNvPr id="5" name="Right Brace 4"/>
          <p:cNvSpPr/>
          <p:nvPr/>
        </p:nvSpPr>
        <p:spPr>
          <a:xfrm>
            <a:off x="7881396" y="400939"/>
            <a:ext cx="379120" cy="2094289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E86B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6" name="Right Brace 5"/>
          <p:cNvSpPr/>
          <p:nvPr/>
        </p:nvSpPr>
        <p:spPr>
          <a:xfrm>
            <a:off x="7908861" y="2495228"/>
            <a:ext cx="379120" cy="759416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E86B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7" name="Right Brace 6"/>
          <p:cNvSpPr/>
          <p:nvPr/>
        </p:nvSpPr>
        <p:spPr>
          <a:xfrm>
            <a:off x="7916610" y="3267561"/>
            <a:ext cx="379120" cy="2172344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E86B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9" name="TextBox 8"/>
          <p:cNvSpPr txBox="1"/>
          <p:nvPr/>
        </p:nvSpPr>
        <p:spPr>
          <a:xfrm>
            <a:off x="8307141" y="1236917"/>
            <a:ext cx="7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/>
              <a:t>ponA2</a:t>
            </a:r>
            <a:endParaRPr lang="en-ZA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8307141" y="2690270"/>
            <a:ext cx="7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/>
              <a:t>ponA3</a:t>
            </a:r>
            <a:endParaRPr lang="en-ZA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8307141" y="4169067"/>
            <a:ext cx="7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/>
              <a:t>ponA1</a:t>
            </a:r>
            <a:endParaRPr lang="en-ZA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 cstate="print">
            <a:lum/>
          </a:blip>
          <a:srcRect/>
          <a:stretch>
            <a:fillRect l="3000" t="3000" r="20000" b="15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/>
          <p:cNvSpPr txBox="1"/>
          <p:nvPr/>
        </p:nvSpPr>
        <p:spPr>
          <a:xfrm>
            <a:off x="6859492" y="149501"/>
            <a:ext cx="671012" cy="550843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>
              <a:lnSpc>
                <a:spcPct val="111000"/>
              </a:lnSpc>
            </a:pP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Rv2864c_PBP</a:t>
            </a:r>
            <a:r>
              <a:rPr lang="en-ZA" sz="500" dirty="0" smtClean="0">
                <a:latin typeface="Arial" pitchFamily="34" charset="0"/>
                <a:cs typeface="Arial" pitchFamily="34" charset="0"/>
              </a:rPr>
              <a:t>-lipo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2933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2889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28690</a:t>
            </a: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2889c</a:t>
            </a:r>
            <a:endParaRPr lang="en-ZA" sz="5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BCG_2886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V_3723</a:t>
            </a: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P2936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OCU_35570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UL_2089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MAR_1840</a:t>
            </a: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L1577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2030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2093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2047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4076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2266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2584</a:t>
            </a: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B_3167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5336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5043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4955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6319</a:t>
            </a: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2080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4630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Rv0016c_pbpA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0018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0019</a:t>
            </a: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0016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BCG_0046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00160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UL_0020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MAR_0018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V_0020</a:t>
            </a: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P0019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OCU_00180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L0018</a:t>
            </a: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0017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0025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0017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0810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0025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0031</a:t>
            </a: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B_0035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Rv2163c_pbpB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2178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21760</a:t>
            </a: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2187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BCG_2180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2221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V_2330</a:t>
            </a: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P1903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OCU_22960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UL_3508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MAR_3200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L0908</a:t>
            </a: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3273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3324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3262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2982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3529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4233</a:t>
            </a:r>
          </a:p>
          <a:p>
            <a:pPr>
              <a:lnSpc>
                <a:spcPct val="111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B_2000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814444" y="5972536"/>
            <a:ext cx="741937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 smtClean="0"/>
              <a:t>Supplementary Figure S3. </a:t>
            </a:r>
            <a:r>
              <a:rPr lang="en-ZA" sz="1200" dirty="0"/>
              <a:t>Phylogenetic relationship between Class </a:t>
            </a:r>
            <a:r>
              <a:rPr lang="en-ZA" sz="1200" dirty="0" smtClean="0"/>
              <a:t>B penicillin </a:t>
            </a:r>
            <a:r>
              <a:rPr lang="en-ZA" sz="1200" dirty="0"/>
              <a:t>binding </a:t>
            </a:r>
            <a:r>
              <a:rPr lang="en-ZA" sz="1200" dirty="0" smtClean="0"/>
              <a:t>proteins (</a:t>
            </a:r>
            <a:r>
              <a:rPr lang="en-ZA" sz="1200" dirty="0" err="1" smtClean="0"/>
              <a:t>Pbp</a:t>
            </a:r>
            <a:r>
              <a:rPr lang="en-ZA" sz="1200" smtClean="0"/>
              <a:t> family) </a:t>
            </a:r>
            <a:r>
              <a:rPr lang="en-ZA" sz="1200" dirty="0"/>
              <a:t>from various </a:t>
            </a:r>
            <a:r>
              <a:rPr lang="en-ZA" sz="1200" dirty="0" smtClean="0"/>
              <a:t>mycobacteria</a:t>
            </a:r>
          </a:p>
          <a:p>
            <a:r>
              <a:rPr lang="en-ZA" sz="1200" dirty="0" smtClean="0"/>
              <a:t>*Duplication of PBP-</a:t>
            </a:r>
            <a:r>
              <a:rPr lang="en-ZA" sz="1200" dirty="0" err="1" smtClean="0"/>
              <a:t>lipo</a:t>
            </a:r>
            <a:r>
              <a:rPr lang="en-ZA" sz="1200" dirty="0" smtClean="0"/>
              <a:t> in environmental species, see text for further details</a:t>
            </a:r>
            <a:endParaRPr lang="en-ZA" sz="1200" dirty="0"/>
          </a:p>
          <a:p>
            <a:endParaRPr lang="en-ZA" sz="1200" dirty="0"/>
          </a:p>
        </p:txBody>
      </p:sp>
      <p:sp>
        <p:nvSpPr>
          <p:cNvPr id="5" name="Right Brace 4"/>
          <p:cNvSpPr/>
          <p:nvPr/>
        </p:nvSpPr>
        <p:spPr>
          <a:xfrm>
            <a:off x="7430835" y="262424"/>
            <a:ext cx="379120" cy="1513989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E86B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6" name="TextBox 5"/>
          <p:cNvSpPr txBox="1"/>
          <p:nvPr/>
        </p:nvSpPr>
        <p:spPr>
          <a:xfrm>
            <a:off x="7740183" y="4545141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err="1" smtClean="0"/>
              <a:t>pbpB</a:t>
            </a:r>
            <a:endParaRPr lang="en-ZA" i="1" dirty="0"/>
          </a:p>
        </p:txBody>
      </p:sp>
      <p:sp>
        <p:nvSpPr>
          <p:cNvPr id="7" name="Right Brace 6"/>
          <p:cNvSpPr/>
          <p:nvPr/>
        </p:nvSpPr>
        <p:spPr>
          <a:xfrm>
            <a:off x="7430835" y="2368257"/>
            <a:ext cx="379120" cy="1560806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E86B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8" name="Right Brace 7"/>
          <p:cNvSpPr/>
          <p:nvPr/>
        </p:nvSpPr>
        <p:spPr>
          <a:xfrm>
            <a:off x="7426072" y="3992269"/>
            <a:ext cx="379120" cy="1513181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E86B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9" name="Right Brace 8"/>
          <p:cNvSpPr/>
          <p:nvPr/>
        </p:nvSpPr>
        <p:spPr>
          <a:xfrm>
            <a:off x="7436126" y="1776413"/>
            <a:ext cx="379120" cy="591845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E86B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0" name="TextBox 9"/>
          <p:cNvSpPr txBox="1"/>
          <p:nvPr/>
        </p:nvSpPr>
        <p:spPr>
          <a:xfrm>
            <a:off x="7735420" y="2954457"/>
            <a:ext cx="673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err="1" smtClean="0"/>
              <a:t>pbpA</a:t>
            </a:r>
            <a:endParaRPr lang="en-ZA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7757562" y="1887669"/>
            <a:ext cx="1075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/>
              <a:t>PBP-</a:t>
            </a:r>
            <a:r>
              <a:rPr lang="en-ZA" i="1" dirty="0" err="1" smtClean="0"/>
              <a:t>lipo</a:t>
            </a:r>
            <a:r>
              <a:rPr lang="en-ZA" dirty="0" smtClean="0"/>
              <a:t>*</a:t>
            </a:r>
            <a:endParaRPr lang="en-ZA" dirty="0"/>
          </a:p>
        </p:txBody>
      </p:sp>
      <p:sp>
        <p:nvSpPr>
          <p:cNvPr id="12" name="TextBox 11"/>
          <p:cNvSpPr txBox="1"/>
          <p:nvPr/>
        </p:nvSpPr>
        <p:spPr>
          <a:xfrm>
            <a:off x="7743801" y="829989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/>
              <a:t>PBP-</a:t>
            </a:r>
            <a:r>
              <a:rPr lang="en-ZA" i="1" dirty="0" err="1" smtClean="0"/>
              <a:t>lipo</a:t>
            </a:r>
            <a:endParaRPr lang="en-ZA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 cstate="print">
            <a:lum/>
          </a:blip>
          <a:srcRect/>
          <a:stretch>
            <a:fillRect l="8000" t="8000" r="20000" b="15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/>
          <p:cNvSpPr txBox="1"/>
          <p:nvPr/>
        </p:nvSpPr>
        <p:spPr>
          <a:xfrm>
            <a:off x="6641251" y="514191"/>
            <a:ext cx="773339" cy="529362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>
              <a:lnSpc>
                <a:spcPct val="122000"/>
              </a:lnSpc>
            </a:pP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F_29150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BCG_2932</a:t>
            </a: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b2935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T2979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RA_2936</a:t>
            </a: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Rv2911_dacB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UL_2045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MAR_1797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V_3766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P2979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OCU_36070</a:t>
            </a: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2008</a:t>
            </a:r>
            <a:endParaRPr lang="en-ZA" sz="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196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194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2433</a:t>
            </a: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218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417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B_3234</a:t>
            </a: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1961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200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1941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4180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2183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2432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V_4305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P3448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OCU_41630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UL_1445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MAR_1192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L0691</a:t>
            </a: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Rv3330_dacB1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RA_3372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T3433</a:t>
            </a: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b3363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BCG_3400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F_33460</a:t>
            </a: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1233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1216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1243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486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156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1661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B_3681</a:t>
            </a: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BCG_3685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F_36340</a:t>
            </a: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b3651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Rv3627c_Rv3627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RA_3663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T3729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UL_4203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MAR_5127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V_0529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P0436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OCU_04440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L0211</a:t>
            </a: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486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4778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516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140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5380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6113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B_0519</a:t>
            </a: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217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4520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1900</a:t>
            </a:r>
          </a:p>
          <a:p>
            <a:pPr>
              <a:lnSpc>
                <a:spcPct val="122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B_2019</a:t>
            </a: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035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034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22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0331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Rectangle 149"/>
          <p:cNvSpPr/>
          <p:nvPr/>
        </p:nvSpPr>
        <p:spPr>
          <a:xfrm>
            <a:off x="6818321" y="516292"/>
            <a:ext cx="216000" cy="25200"/>
          </a:xfrm>
          <a:prstGeom prst="rect">
            <a:avLst/>
          </a:prstGeom>
          <a:solidFill>
            <a:schemeClr val="bg1"/>
          </a:solidFill>
          <a:ln w="3175"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4" name="TextBox 3"/>
          <p:cNvSpPr txBox="1"/>
          <p:nvPr/>
        </p:nvSpPr>
        <p:spPr>
          <a:xfrm>
            <a:off x="822193" y="5972536"/>
            <a:ext cx="76941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/>
              <a:t>Supplementary Figure </a:t>
            </a:r>
            <a:r>
              <a:rPr lang="en-ZA" sz="1200" b="1" dirty="0" smtClean="0"/>
              <a:t>S4. </a:t>
            </a:r>
            <a:r>
              <a:rPr lang="en-ZA" sz="1200" dirty="0"/>
              <a:t>Phylogenetic relationship between Class C</a:t>
            </a:r>
            <a:r>
              <a:rPr lang="en-ZA" sz="1200" dirty="0" smtClean="0"/>
              <a:t> </a:t>
            </a:r>
            <a:r>
              <a:rPr lang="en-ZA" sz="1200" dirty="0"/>
              <a:t>penicillin binding </a:t>
            </a:r>
            <a:r>
              <a:rPr lang="en-ZA" sz="1200" dirty="0" smtClean="0"/>
              <a:t>proteins (</a:t>
            </a:r>
            <a:r>
              <a:rPr lang="en-ZA" sz="1050" dirty="0" smtClean="0"/>
              <a:t>DD</a:t>
            </a:r>
            <a:r>
              <a:rPr lang="en-ZA" sz="1200" dirty="0" smtClean="0"/>
              <a:t>-</a:t>
            </a:r>
            <a:r>
              <a:rPr lang="en-ZA" sz="1200" dirty="0" err="1" smtClean="0"/>
              <a:t>carboxypeptidases</a:t>
            </a:r>
            <a:r>
              <a:rPr lang="en-ZA" sz="1200" dirty="0" smtClean="0"/>
              <a:t>) from </a:t>
            </a:r>
            <a:r>
              <a:rPr lang="en-ZA" sz="1200" dirty="0"/>
              <a:t>various mycobacteria</a:t>
            </a:r>
          </a:p>
          <a:p>
            <a:r>
              <a:rPr lang="en-ZA" sz="1200" dirty="0"/>
              <a:t>*Duplication of </a:t>
            </a:r>
            <a:r>
              <a:rPr lang="en-ZA" sz="1200" i="1" dirty="0" smtClean="0"/>
              <a:t>dacB2</a:t>
            </a:r>
            <a:r>
              <a:rPr lang="en-ZA" sz="1200" dirty="0" smtClean="0"/>
              <a:t> </a:t>
            </a:r>
            <a:r>
              <a:rPr lang="en-ZA" sz="1200" dirty="0"/>
              <a:t>in environmental species, see text for further details</a:t>
            </a:r>
          </a:p>
          <a:p>
            <a:endParaRPr lang="en-ZA" sz="1200" dirty="0"/>
          </a:p>
        </p:txBody>
      </p:sp>
      <p:sp>
        <p:nvSpPr>
          <p:cNvPr id="5" name="Right Brace 4"/>
          <p:cNvSpPr/>
          <p:nvPr/>
        </p:nvSpPr>
        <p:spPr>
          <a:xfrm>
            <a:off x="7135560" y="610895"/>
            <a:ext cx="379120" cy="1232193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E86B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6" name="Right Brace 5"/>
          <p:cNvSpPr/>
          <p:nvPr/>
        </p:nvSpPr>
        <p:spPr>
          <a:xfrm>
            <a:off x="7135560" y="2428875"/>
            <a:ext cx="379120" cy="1266825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E86B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7" name="Right Brace 6"/>
          <p:cNvSpPr/>
          <p:nvPr/>
        </p:nvSpPr>
        <p:spPr>
          <a:xfrm>
            <a:off x="7135560" y="3810000"/>
            <a:ext cx="379120" cy="1333500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E86B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8" name="Right Brace 7"/>
          <p:cNvSpPr/>
          <p:nvPr/>
        </p:nvSpPr>
        <p:spPr>
          <a:xfrm>
            <a:off x="7135560" y="5205413"/>
            <a:ext cx="379120" cy="533400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E86B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9" name="TextBox 8"/>
          <p:cNvSpPr txBox="1"/>
          <p:nvPr/>
        </p:nvSpPr>
        <p:spPr>
          <a:xfrm>
            <a:off x="7454432" y="1042325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/>
              <a:t>dacB2</a:t>
            </a:r>
            <a:endParaRPr lang="en-ZA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7447998" y="2877621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/>
              <a:t>dacB1</a:t>
            </a:r>
            <a:endParaRPr lang="en-ZA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7444895" y="4292084"/>
            <a:ext cx="973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/>
              <a:t>Rv3627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454432" y="5287447"/>
            <a:ext cx="1521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/>
              <a:t>MSMEG_1900</a:t>
            </a:r>
            <a:endParaRPr lang="en-ZA" i="1" dirty="0"/>
          </a:p>
        </p:txBody>
      </p:sp>
      <p:sp>
        <p:nvSpPr>
          <p:cNvPr id="13" name="Right Brace 12"/>
          <p:cNvSpPr/>
          <p:nvPr/>
        </p:nvSpPr>
        <p:spPr>
          <a:xfrm>
            <a:off x="7135560" y="1905000"/>
            <a:ext cx="379120" cy="523875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E86B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4" name="TextBox 13"/>
          <p:cNvSpPr txBox="1"/>
          <p:nvPr/>
        </p:nvSpPr>
        <p:spPr>
          <a:xfrm>
            <a:off x="7447998" y="1966245"/>
            <a:ext cx="875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/>
              <a:t>dacB2*</a:t>
            </a:r>
            <a:endParaRPr lang="en-ZA" i="1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 cstate="print">
            <a:lum/>
          </a:blip>
          <a:srcRect/>
          <a:stretch>
            <a:fillRect l="5000" t="5000" r="15000" b="20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Rectangle 149"/>
          <p:cNvSpPr/>
          <p:nvPr/>
        </p:nvSpPr>
        <p:spPr>
          <a:xfrm>
            <a:off x="6818321" y="516292"/>
            <a:ext cx="216000" cy="25200"/>
          </a:xfrm>
          <a:prstGeom prst="rect">
            <a:avLst/>
          </a:prstGeom>
          <a:solidFill>
            <a:schemeClr val="bg1"/>
          </a:solidFill>
          <a:ln w="3175"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0" name="TextBox 49"/>
          <p:cNvSpPr txBox="1"/>
          <p:nvPr/>
        </p:nvSpPr>
        <p:spPr>
          <a:xfrm>
            <a:off x="7380090" y="336251"/>
            <a:ext cx="481874" cy="516013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>
              <a:lnSpc>
                <a:spcPct val="71000"/>
              </a:lnSpc>
            </a:pP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Rv2190c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RA_2205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F_22010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b2213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BCG_2206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T2245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UL3545_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MAR_3234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AP1928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V_2304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OCU_22720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L0885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328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334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3298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4256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355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295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5661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5350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3713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2808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5385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4528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1435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1453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4570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0888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B_1974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Rv0024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RA_0027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T0027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F_00240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b002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BCG_0054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V_0042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P0036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OCU_00360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UL_0042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MAR_0043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Rv1566c ripD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T1617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RA_1578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b1593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BCG_1619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F_15930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L1214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V_3208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AP1272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OCU_30430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UL_1557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MAR_2381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2970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3253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3477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267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271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270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B_2474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AB_2727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Rv1478 </a:t>
            </a: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ripB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BCG_1540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RA_1488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T1525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F_15010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b151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UL_1487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MAR_2285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V_3300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P1204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OCU_31410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L1811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365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5720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5288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2843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090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568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532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455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144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1465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447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245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249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248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3146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2748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452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BCG_1539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b1513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F_15000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RA_1487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Rv1477 ripA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T1524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UL_1486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MAR_2284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L1812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V_3301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P1203</a:t>
            </a: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OCU_31420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2451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2496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2488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3145</a:t>
            </a: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274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3663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5716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529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3656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0895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456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283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1440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1458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4520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1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AB_2728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830505" y="5915386"/>
            <a:ext cx="74193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/>
              <a:t>Supplementary Figure </a:t>
            </a:r>
            <a:r>
              <a:rPr lang="en-ZA" sz="1200" b="1" dirty="0" smtClean="0"/>
              <a:t>S5. </a:t>
            </a:r>
            <a:r>
              <a:rPr lang="en-ZA" sz="1200" dirty="0"/>
              <a:t>Phylogenetic relationship between </a:t>
            </a:r>
            <a:r>
              <a:rPr lang="en-ZA" sz="1200" dirty="0" smtClean="0"/>
              <a:t>endopeptidases (</a:t>
            </a:r>
            <a:r>
              <a:rPr lang="en-ZA" sz="1200" dirty="0" err="1" smtClean="0"/>
              <a:t>Nlp</a:t>
            </a:r>
            <a:r>
              <a:rPr lang="en-ZA" sz="1200" dirty="0" smtClean="0"/>
              <a:t>/P60 – domain containing proteins) from </a:t>
            </a:r>
            <a:r>
              <a:rPr lang="en-ZA" sz="1200" dirty="0"/>
              <a:t>various </a:t>
            </a:r>
            <a:r>
              <a:rPr lang="en-ZA" sz="1200" dirty="0" smtClean="0"/>
              <a:t>mycobacteria</a:t>
            </a:r>
            <a:endParaRPr lang="en-ZA" sz="1200" dirty="0"/>
          </a:p>
        </p:txBody>
      </p:sp>
      <p:sp>
        <p:nvSpPr>
          <p:cNvPr id="5" name="Right Brace 4"/>
          <p:cNvSpPr/>
          <p:nvPr/>
        </p:nvSpPr>
        <p:spPr>
          <a:xfrm>
            <a:off x="7718026" y="383382"/>
            <a:ext cx="379120" cy="1178717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BF237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6" name="TextBox 5"/>
          <p:cNvSpPr txBox="1"/>
          <p:nvPr/>
        </p:nvSpPr>
        <p:spPr>
          <a:xfrm>
            <a:off x="8011353" y="760509"/>
            <a:ext cx="973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/>
              <a:t>Rv2190c</a:t>
            </a:r>
            <a:endParaRPr lang="en-ZA" i="1" dirty="0"/>
          </a:p>
        </p:txBody>
      </p:sp>
      <p:sp>
        <p:nvSpPr>
          <p:cNvPr id="8" name="Right Brace 7"/>
          <p:cNvSpPr/>
          <p:nvPr/>
        </p:nvSpPr>
        <p:spPr>
          <a:xfrm>
            <a:off x="7718026" y="1638302"/>
            <a:ext cx="379120" cy="453745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BF237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9" name="Right Brace 8"/>
          <p:cNvSpPr/>
          <p:nvPr/>
        </p:nvSpPr>
        <p:spPr>
          <a:xfrm>
            <a:off x="7718026" y="2114552"/>
            <a:ext cx="379120" cy="745330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BF237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0" name="Right Brace 9"/>
          <p:cNvSpPr/>
          <p:nvPr/>
        </p:nvSpPr>
        <p:spPr>
          <a:xfrm>
            <a:off x="7718026" y="2959895"/>
            <a:ext cx="379120" cy="1250155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BF237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1" name="Right Brace 10"/>
          <p:cNvSpPr/>
          <p:nvPr/>
        </p:nvSpPr>
        <p:spPr>
          <a:xfrm>
            <a:off x="7717481" y="4246227"/>
            <a:ext cx="379120" cy="1133017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BF237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2" name="TextBox 11"/>
          <p:cNvSpPr txBox="1"/>
          <p:nvPr/>
        </p:nvSpPr>
        <p:spPr>
          <a:xfrm>
            <a:off x="8010867" y="1666219"/>
            <a:ext cx="877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/>
              <a:t>Rv0024</a:t>
            </a:r>
            <a:endParaRPr lang="en-ZA" i="1" dirty="0"/>
          </a:p>
        </p:txBody>
      </p:sp>
      <p:sp>
        <p:nvSpPr>
          <p:cNvPr id="13" name="TextBox 12"/>
          <p:cNvSpPr txBox="1"/>
          <p:nvPr/>
        </p:nvSpPr>
        <p:spPr>
          <a:xfrm>
            <a:off x="8012728" y="2297781"/>
            <a:ext cx="5774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err="1" smtClean="0"/>
              <a:t>ripD</a:t>
            </a:r>
            <a:endParaRPr lang="en-ZA" i="1" dirty="0"/>
          </a:p>
        </p:txBody>
      </p:sp>
      <p:sp>
        <p:nvSpPr>
          <p:cNvPr id="14" name="TextBox 13"/>
          <p:cNvSpPr txBox="1"/>
          <p:nvPr/>
        </p:nvSpPr>
        <p:spPr>
          <a:xfrm>
            <a:off x="8025156" y="3371728"/>
            <a:ext cx="559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err="1" smtClean="0"/>
              <a:t>ripB</a:t>
            </a:r>
            <a:endParaRPr lang="en-ZA" i="1" dirty="0"/>
          </a:p>
        </p:txBody>
      </p:sp>
      <p:sp>
        <p:nvSpPr>
          <p:cNvPr id="15" name="TextBox 14"/>
          <p:cNvSpPr txBox="1"/>
          <p:nvPr/>
        </p:nvSpPr>
        <p:spPr>
          <a:xfrm>
            <a:off x="8034682" y="4604254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err="1" smtClean="0"/>
              <a:t>ripA</a:t>
            </a:r>
            <a:endParaRPr lang="en-ZA" i="1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 cstate="print">
            <a:lum/>
          </a:blip>
          <a:srcRect/>
          <a:stretch>
            <a:fillRect l="5000" t="5000" r="15000" b="20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TextBox 82"/>
          <p:cNvSpPr txBox="1"/>
          <p:nvPr/>
        </p:nvSpPr>
        <p:spPr>
          <a:xfrm>
            <a:off x="7233956" y="348195"/>
            <a:ext cx="546942" cy="520052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>
              <a:lnSpc>
                <a:spcPct val="79000"/>
              </a:lnSpc>
            </a:pP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Rv0116c</a:t>
            </a:r>
            <a:r>
              <a:rPr lang="en-ZA" sz="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ldt</a:t>
            </a:r>
            <a:r>
              <a:rPr lang="en-ZA" sz="400" baseline="-25000" dirty="0" err="1" smtClean="0">
                <a:latin typeface="Arial" pitchFamily="34" charset="0"/>
                <a:cs typeface="Arial" pitchFamily="34" charset="0"/>
              </a:rPr>
              <a:t>Mt1</a:t>
            </a:r>
            <a:endParaRPr lang="en-ZA" sz="400" baseline="-250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RA_0123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b0120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BCG_0150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F_01170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T0125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UL_4806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MAR_0316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L2664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V_5194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AP3520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OCU_50160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2773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272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275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3528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AB_3165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3298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301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4515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Rv1433 </a:t>
            </a: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ldt</a:t>
            </a:r>
            <a:r>
              <a:rPr lang="en-ZA" sz="400" baseline="-25000" dirty="0" err="1" smtClean="0">
                <a:latin typeface="Arial" pitchFamily="34" charset="0"/>
                <a:cs typeface="Arial" pitchFamily="34" charset="0"/>
              </a:rPr>
              <a:t>Mt3</a:t>
            </a:r>
            <a:endParaRPr lang="en-ZA" sz="400" baseline="-250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RA_1442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T1477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F_14550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b1468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BCG_1494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V_4834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AP3812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OCU_47330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L0569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MAR_3552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0674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139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AB_4775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0160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0151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0141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047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017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0233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5680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5330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369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282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536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4535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F_01930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b0198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BCG_0229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Rv0192</a:t>
            </a:r>
            <a:r>
              <a:rPr lang="en-ZA" sz="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ldt</a:t>
            </a:r>
            <a:r>
              <a:rPr lang="en-ZA" sz="400" baseline="-25000" dirty="0" err="1" smtClean="0">
                <a:latin typeface="Arial" pitchFamily="34" charset="0"/>
                <a:cs typeface="Arial" pitchFamily="34" charset="0"/>
              </a:rPr>
              <a:t>Mt4</a:t>
            </a:r>
            <a:endParaRPr lang="en-ZA" sz="400" baseline="-250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RA_0200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T0202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UL_1085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MAR_0435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V_4986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P3634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OCU_48990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AB_4537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5721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528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3651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090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4556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1448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1466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585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453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3646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371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3641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410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2542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4745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Rv2518c</a:t>
            </a:r>
            <a:r>
              <a:rPr lang="en-ZA" sz="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ldt</a:t>
            </a:r>
            <a:r>
              <a:rPr lang="en-ZA" sz="400" baseline="-25000" dirty="0" err="1" smtClean="0">
                <a:latin typeface="Arial" pitchFamily="34" charset="0"/>
                <a:cs typeface="Arial" pitchFamily="34" charset="0"/>
              </a:rPr>
              <a:t>Mt2</a:t>
            </a:r>
            <a:endParaRPr lang="en-ZA" sz="400" baseline="-250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RA_2545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BCG_2539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T2594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b2547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F_25330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L0426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V_1661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AP2322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OCU_17500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UL_3804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MAR_3872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B_1530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Rv0483</a:t>
            </a:r>
            <a:r>
              <a:rPr lang="en-ZA" sz="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ldt</a:t>
            </a:r>
            <a:r>
              <a:rPr lang="en-ZA" sz="400" baseline="-25000" dirty="0" err="1" smtClean="0">
                <a:latin typeface="Arial" pitchFamily="34" charset="0"/>
                <a:cs typeface="Arial" pitchFamily="34" charset="0"/>
              </a:rPr>
              <a:t>Mt5</a:t>
            </a:r>
            <a:endParaRPr lang="en-ZA" sz="400" baseline="-250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RA_0490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T0501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F_04870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b0493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BCG_0524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UL_4553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MAR_0809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V_4666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AP3976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OCU_45320</a:t>
            </a: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L2446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kms_066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mcs_065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jls_0647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flv_0089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van_0824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r>
              <a:rPr lang="en-ZA" sz="400" dirty="0" smtClean="0">
                <a:latin typeface="Arial" pitchFamily="34" charset="0"/>
                <a:cs typeface="Arial" pitchFamily="34" charset="0"/>
              </a:rPr>
              <a:t>MSMEG_0929</a:t>
            </a:r>
          </a:p>
          <a:p>
            <a:pPr>
              <a:lnSpc>
                <a:spcPct val="79000"/>
              </a:lnSpc>
            </a:pPr>
            <a:r>
              <a:rPr lang="en-ZA" sz="400" dirty="0" err="1" smtClean="0">
                <a:latin typeface="Arial" pitchFamily="34" charset="0"/>
                <a:cs typeface="Arial" pitchFamily="34" charset="0"/>
              </a:rPr>
              <a:t>MAB_4061c</a:t>
            </a:r>
            <a:endParaRPr lang="en-ZA" sz="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9000"/>
              </a:lnSpc>
            </a:pPr>
            <a:endParaRPr lang="en-ZA" sz="4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840143" y="5926042"/>
            <a:ext cx="74193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/>
              <a:t>Supplementary Figure </a:t>
            </a:r>
            <a:r>
              <a:rPr lang="en-ZA" sz="1200" b="1" dirty="0" smtClean="0"/>
              <a:t>S6. </a:t>
            </a:r>
            <a:r>
              <a:rPr lang="en-ZA" sz="1200" dirty="0"/>
              <a:t>Phylogenetic relationship </a:t>
            </a:r>
            <a:r>
              <a:rPr lang="en-ZA" sz="1200" dirty="0" smtClean="0"/>
              <a:t>between </a:t>
            </a:r>
            <a:r>
              <a:rPr lang="en-ZA" sz="1050" dirty="0" smtClean="0"/>
              <a:t>L,D</a:t>
            </a:r>
            <a:r>
              <a:rPr lang="en-ZA" sz="1200" dirty="0" smtClean="0"/>
              <a:t>-transpeptidases from </a:t>
            </a:r>
            <a:r>
              <a:rPr lang="en-ZA" sz="1200" dirty="0"/>
              <a:t>various </a:t>
            </a:r>
            <a:r>
              <a:rPr lang="en-ZA" sz="1200" dirty="0" smtClean="0"/>
              <a:t>mycobacteria</a:t>
            </a:r>
          </a:p>
          <a:p>
            <a:r>
              <a:rPr lang="en-ZA" sz="1200" dirty="0" smtClean="0"/>
              <a:t>* Larger clades comprise gene duplications in environmental strains</a:t>
            </a:r>
            <a:endParaRPr lang="en-ZA" sz="1200" dirty="0"/>
          </a:p>
        </p:txBody>
      </p:sp>
      <p:sp>
        <p:nvSpPr>
          <p:cNvPr id="29" name="Right Brace 28"/>
          <p:cNvSpPr/>
          <p:nvPr/>
        </p:nvSpPr>
        <p:spPr>
          <a:xfrm>
            <a:off x="7655562" y="381530"/>
            <a:ext cx="379120" cy="961496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89CC4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30" name="TextBox 29"/>
          <p:cNvSpPr txBox="1"/>
          <p:nvPr/>
        </p:nvSpPr>
        <p:spPr>
          <a:xfrm>
            <a:off x="7929907" y="4804318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>
                <a:cs typeface="Arial" pitchFamily="34" charset="0"/>
              </a:rPr>
              <a:t> ldt</a:t>
            </a:r>
            <a:r>
              <a:rPr lang="en-ZA" baseline="-25000" dirty="0">
                <a:cs typeface="Arial" pitchFamily="34" charset="0"/>
              </a:rPr>
              <a:t>Mt5</a:t>
            </a:r>
            <a:endParaRPr lang="en-ZA" i="1" dirty="0"/>
          </a:p>
        </p:txBody>
      </p:sp>
      <p:sp>
        <p:nvSpPr>
          <p:cNvPr id="31" name="Right Brace 30"/>
          <p:cNvSpPr/>
          <p:nvPr/>
        </p:nvSpPr>
        <p:spPr>
          <a:xfrm>
            <a:off x="7655906" y="1362605"/>
            <a:ext cx="379120" cy="647170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89CC4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32" name="Right Brace 31"/>
          <p:cNvSpPr/>
          <p:nvPr/>
        </p:nvSpPr>
        <p:spPr>
          <a:xfrm>
            <a:off x="7655906" y="2041262"/>
            <a:ext cx="379120" cy="1075794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89CC4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33" name="Right Brace 32"/>
          <p:cNvSpPr/>
          <p:nvPr/>
        </p:nvSpPr>
        <p:spPr>
          <a:xfrm>
            <a:off x="7655906" y="3196169"/>
            <a:ext cx="379120" cy="1290106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89CC4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35" name="Right Brace 34"/>
          <p:cNvSpPr/>
          <p:nvPr/>
        </p:nvSpPr>
        <p:spPr>
          <a:xfrm>
            <a:off x="7655562" y="4560625"/>
            <a:ext cx="379120" cy="890056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89CC4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36" name="TextBox 35"/>
          <p:cNvSpPr txBox="1"/>
          <p:nvPr/>
        </p:nvSpPr>
        <p:spPr>
          <a:xfrm>
            <a:off x="7914409" y="2386744"/>
            <a:ext cx="86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>
                <a:cs typeface="Arial" pitchFamily="34" charset="0"/>
              </a:rPr>
              <a:t> </a:t>
            </a:r>
            <a:r>
              <a:rPr lang="en-ZA" dirty="0" smtClean="0">
                <a:cs typeface="Arial" pitchFamily="34" charset="0"/>
              </a:rPr>
              <a:t>ldt</a:t>
            </a:r>
            <a:r>
              <a:rPr lang="en-ZA" baseline="-25000" dirty="0" smtClean="0">
                <a:cs typeface="Arial" pitchFamily="34" charset="0"/>
              </a:rPr>
              <a:t>Mt4</a:t>
            </a:r>
            <a:r>
              <a:rPr lang="en-ZA" dirty="0" smtClean="0">
                <a:cs typeface="Arial" pitchFamily="34" charset="0"/>
              </a:rPr>
              <a:t>*</a:t>
            </a:r>
            <a:endParaRPr lang="en-ZA" i="1" dirty="0"/>
          </a:p>
        </p:txBody>
      </p:sp>
      <p:sp>
        <p:nvSpPr>
          <p:cNvPr id="37" name="TextBox 36"/>
          <p:cNvSpPr txBox="1"/>
          <p:nvPr/>
        </p:nvSpPr>
        <p:spPr>
          <a:xfrm>
            <a:off x="7902949" y="3639788"/>
            <a:ext cx="86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>
                <a:cs typeface="Arial" pitchFamily="34" charset="0"/>
              </a:rPr>
              <a:t> </a:t>
            </a:r>
            <a:r>
              <a:rPr lang="en-ZA" dirty="0" smtClean="0">
                <a:cs typeface="Arial" pitchFamily="34" charset="0"/>
              </a:rPr>
              <a:t>ldt</a:t>
            </a:r>
            <a:r>
              <a:rPr lang="en-ZA" baseline="-25000" dirty="0" smtClean="0">
                <a:cs typeface="Arial" pitchFamily="34" charset="0"/>
              </a:rPr>
              <a:t>Mt2</a:t>
            </a:r>
            <a:r>
              <a:rPr lang="en-ZA" dirty="0" smtClean="0">
                <a:cs typeface="Arial" pitchFamily="34" charset="0"/>
              </a:rPr>
              <a:t>*</a:t>
            </a:r>
            <a:endParaRPr lang="en-ZA" i="1" dirty="0"/>
          </a:p>
        </p:txBody>
      </p:sp>
      <p:sp>
        <p:nvSpPr>
          <p:cNvPr id="38" name="TextBox 37"/>
          <p:cNvSpPr txBox="1"/>
          <p:nvPr/>
        </p:nvSpPr>
        <p:spPr>
          <a:xfrm>
            <a:off x="7914409" y="1482474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>
                <a:cs typeface="Arial" pitchFamily="34" charset="0"/>
              </a:rPr>
              <a:t> </a:t>
            </a:r>
            <a:r>
              <a:rPr lang="en-ZA" dirty="0" smtClean="0">
                <a:cs typeface="Arial" pitchFamily="34" charset="0"/>
              </a:rPr>
              <a:t>ldt</a:t>
            </a:r>
            <a:r>
              <a:rPr lang="en-ZA" baseline="-25000" dirty="0" smtClean="0">
                <a:cs typeface="Arial" pitchFamily="34" charset="0"/>
              </a:rPr>
              <a:t>Mt3</a:t>
            </a:r>
            <a:endParaRPr lang="en-ZA" i="1" dirty="0"/>
          </a:p>
        </p:txBody>
      </p:sp>
      <p:sp>
        <p:nvSpPr>
          <p:cNvPr id="39" name="TextBox 38"/>
          <p:cNvSpPr txBox="1"/>
          <p:nvPr/>
        </p:nvSpPr>
        <p:spPr>
          <a:xfrm>
            <a:off x="7922158" y="677612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>
                <a:cs typeface="Arial" pitchFamily="34" charset="0"/>
              </a:rPr>
              <a:t> </a:t>
            </a:r>
            <a:r>
              <a:rPr lang="en-ZA" dirty="0" smtClean="0">
                <a:cs typeface="Arial" pitchFamily="34" charset="0"/>
              </a:rPr>
              <a:t>ldt</a:t>
            </a:r>
            <a:r>
              <a:rPr lang="en-ZA" baseline="-25000" dirty="0" smtClean="0">
                <a:cs typeface="Arial" pitchFamily="34" charset="0"/>
              </a:rPr>
              <a:t>Mt1</a:t>
            </a:r>
            <a:endParaRPr lang="en-ZA" i="1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 cstate="print">
            <a:lum/>
          </a:blip>
          <a:srcRect/>
          <a:stretch>
            <a:fillRect l="5000" t="5000" r="15000" b="20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Rectangle 149"/>
          <p:cNvSpPr/>
          <p:nvPr/>
        </p:nvSpPr>
        <p:spPr>
          <a:xfrm>
            <a:off x="6818321" y="516292"/>
            <a:ext cx="216000" cy="25200"/>
          </a:xfrm>
          <a:prstGeom prst="rect">
            <a:avLst/>
          </a:prstGeom>
          <a:solidFill>
            <a:schemeClr val="bg1"/>
          </a:solidFill>
          <a:ln w="3175"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0" name="TextBox 49"/>
          <p:cNvSpPr txBox="1"/>
          <p:nvPr/>
        </p:nvSpPr>
        <p:spPr>
          <a:xfrm>
            <a:off x="7390110" y="292074"/>
            <a:ext cx="585101" cy="522450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>
              <a:lnSpc>
                <a:spcPct val="97000"/>
              </a:lnSpc>
            </a:pP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Rv3811 ami3</a:t>
            </a: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3841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BCG3873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3918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3851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38260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UL_4995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MAR_5375</a:t>
            </a: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P0209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V_0206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OCU_02160</a:t>
            </a: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5110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5022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5403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6406</a:t>
            </a: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5652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1157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B_0168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B_4807</a:t>
            </a: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4180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3376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4402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5315</a:t>
            </a: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3152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4246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Rv3594 ami4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3700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3633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BCG_3659</a:t>
            </a: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3625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36070</a:t>
            </a: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3946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39300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BCG_0021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3954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4034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Rv3915 ami2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MAR_5479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UL_5068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L2704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V_5303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P4341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6935</a:t>
            </a: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5493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5780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5404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0837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6069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B_4942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Rv3717 ami1</a:t>
            </a: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b3744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RA_3754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BCG_3777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T3820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F_37260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MAR_5233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UL_4308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L2331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P0318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AV_0385</a:t>
            </a: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OCU_03450</a:t>
            </a: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mcs_4905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kms_4994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jls_5273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van_5529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flv_1286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MSMEG_6281</a:t>
            </a:r>
          </a:p>
          <a:p>
            <a:pPr>
              <a:lnSpc>
                <a:spcPct val="97000"/>
              </a:lnSpc>
            </a:pPr>
            <a:r>
              <a:rPr lang="en-ZA" sz="500" dirty="0" err="1" smtClean="0">
                <a:latin typeface="Arial" pitchFamily="34" charset="0"/>
                <a:cs typeface="Arial" pitchFamily="34" charset="0"/>
              </a:rPr>
              <a:t>MAB_0318c</a:t>
            </a:r>
            <a:endParaRPr lang="en-ZA" sz="5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97000"/>
              </a:lnSpc>
            </a:pPr>
            <a:r>
              <a:rPr lang="en-ZA" sz="500" dirty="0" smtClean="0">
                <a:latin typeface="Arial" pitchFamily="34" charset="0"/>
                <a:cs typeface="Arial" pitchFamily="34" charset="0"/>
              </a:rPr>
              <a:t>OCU_51370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845440" y="5933791"/>
            <a:ext cx="74193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/>
              <a:t>Supplementary Figure </a:t>
            </a:r>
            <a:r>
              <a:rPr lang="en-ZA" sz="1200" b="1" dirty="0" smtClean="0"/>
              <a:t>S7. </a:t>
            </a:r>
            <a:r>
              <a:rPr lang="en-ZA" sz="1200" dirty="0"/>
              <a:t>Phylogenetic relationship between </a:t>
            </a:r>
            <a:r>
              <a:rPr lang="en-ZA" sz="1200" i="1" dirty="0" smtClean="0"/>
              <a:t>N</a:t>
            </a:r>
            <a:r>
              <a:rPr lang="en-ZA" sz="1200" dirty="0" smtClean="0"/>
              <a:t>-acetylmuramoyl-</a:t>
            </a:r>
            <a:r>
              <a:rPr lang="en-ZA" sz="1000" dirty="0" smtClean="0"/>
              <a:t>L</a:t>
            </a:r>
            <a:r>
              <a:rPr lang="en-ZA" sz="1200" dirty="0" smtClean="0"/>
              <a:t>-amidases from </a:t>
            </a:r>
            <a:r>
              <a:rPr lang="en-ZA" sz="1200" dirty="0"/>
              <a:t>various </a:t>
            </a:r>
            <a:r>
              <a:rPr lang="en-ZA" sz="1200" dirty="0" smtClean="0"/>
              <a:t>mycobacteria</a:t>
            </a:r>
            <a:endParaRPr lang="en-ZA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8096191" y="792316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>
                <a:cs typeface="Arial" pitchFamily="34" charset="0"/>
              </a:rPr>
              <a:t>ami3</a:t>
            </a:r>
            <a:endParaRPr lang="en-ZA" i="1" dirty="0"/>
          </a:p>
        </p:txBody>
      </p:sp>
      <p:sp>
        <p:nvSpPr>
          <p:cNvPr id="7" name="Right Brace 6"/>
          <p:cNvSpPr/>
          <p:nvPr/>
        </p:nvSpPr>
        <p:spPr>
          <a:xfrm>
            <a:off x="7791460" y="404495"/>
            <a:ext cx="379120" cy="1181418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3CA2B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8" name="Right Brace 7"/>
          <p:cNvSpPr/>
          <p:nvPr/>
        </p:nvSpPr>
        <p:spPr>
          <a:xfrm>
            <a:off x="7791460" y="1722909"/>
            <a:ext cx="379120" cy="920279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3CA2B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9" name="Right Brace 8"/>
          <p:cNvSpPr/>
          <p:nvPr/>
        </p:nvSpPr>
        <p:spPr>
          <a:xfrm>
            <a:off x="7791460" y="2684934"/>
            <a:ext cx="379120" cy="1210791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3CA2B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0" name="Right Brace 9"/>
          <p:cNvSpPr/>
          <p:nvPr/>
        </p:nvSpPr>
        <p:spPr>
          <a:xfrm>
            <a:off x="7791460" y="3970608"/>
            <a:ext cx="379120" cy="1458642"/>
          </a:xfrm>
          <a:prstGeom prst="rightBrace">
            <a:avLst>
              <a:gd name="adj1" fmla="val 70033"/>
              <a:gd name="adj2" fmla="val 50000"/>
            </a:avLst>
          </a:prstGeom>
          <a:ln w="19050">
            <a:solidFill>
              <a:srgbClr val="3CA2B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1" name="TextBox 10"/>
          <p:cNvSpPr txBox="1"/>
          <p:nvPr/>
        </p:nvSpPr>
        <p:spPr>
          <a:xfrm>
            <a:off x="8100254" y="1979330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>
                <a:cs typeface="Arial" pitchFamily="34" charset="0"/>
              </a:rPr>
              <a:t>ami4</a:t>
            </a:r>
            <a:endParaRPr lang="en-ZA" i="1" dirty="0"/>
          </a:p>
        </p:txBody>
      </p:sp>
      <p:sp>
        <p:nvSpPr>
          <p:cNvPr id="12" name="TextBox 11"/>
          <p:cNvSpPr txBox="1"/>
          <p:nvPr/>
        </p:nvSpPr>
        <p:spPr>
          <a:xfrm>
            <a:off x="8085970" y="3091374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>
                <a:cs typeface="Arial" pitchFamily="34" charset="0"/>
              </a:rPr>
              <a:t>ami2</a:t>
            </a:r>
            <a:endParaRPr lang="en-ZA" i="1" dirty="0"/>
          </a:p>
        </p:txBody>
      </p:sp>
      <p:sp>
        <p:nvSpPr>
          <p:cNvPr id="13" name="TextBox 12"/>
          <p:cNvSpPr txBox="1"/>
          <p:nvPr/>
        </p:nvSpPr>
        <p:spPr>
          <a:xfrm>
            <a:off x="8095491" y="4500974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i="1" dirty="0" smtClean="0">
                <a:cs typeface="Arial" pitchFamily="34" charset="0"/>
              </a:rPr>
              <a:t>ami1</a:t>
            </a:r>
            <a:endParaRPr lang="en-ZA" i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97</TotalTime>
  <Words>756</Words>
  <Application>Microsoft Office PowerPoint</Application>
  <PresentationFormat>On-screen Show (4:3)</PresentationFormat>
  <Paragraphs>599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the Witwatersran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reem</dc:creator>
  <cp:lastModifiedBy>wits-user</cp:lastModifiedBy>
  <cp:revision>241</cp:revision>
  <dcterms:created xsi:type="dcterms:W3CDTF">2014-02-14T01:46:25Z</dcterms:created>
  <dcterms:modified xsi:type="dcterms:W3CDTF">2014-02-21T06:50:36Z</dcterms:modified>
</cp:coreProperties>
</file>